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60" r:id="rId4"/>
    <p:sldId id="259" r:id="rId5"/>
  </p:sldIdLst>
  <p:sldSz cx="12192000" cy="6858000"/>
  <p:notesSz cx="6858000" cy="9144000"/>
  <p:defaultTextStyle>
    <a:defPPr>
      <a:defRPr lang="en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626"/>
  </p:normalViewPr>
  <p:slideViewPr>
    <p:cSldViewPr snapToGrid="0">
      <p:cViewPr varScale="1">
        <p:scale>
          <a:sx n="116" d="100"/>
          <a:sy n="116" d="100"/>
        </p:scale>
        <p:origin x="451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B8502D-CE63-4D24-8B0F-B6E9BB9B18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172971B-DC4B-842A-7025-AFD11C53B5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26DC7-4F00-982A-0FA6-59B83128C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2EDB14-58C3-1FA7-F668-366C9A84A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090D29-C28A-AF63-9872-19CC3ED45B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58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9F72A-7F98-9DB7-4859-FEDC1781F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2506EC-BA27-D5DF-F2BE-2A27A7EBD1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F6B34C-9636-8658-C736-724A3452B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BFB622-BD64-3F81-9BC9-62BE10302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90B57E-13EE-02AB-1F9C-753A1A575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033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E15D6F-30B1-1BF7-9153-91E1DD18B7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70623C-4473-A51F-F1DB-30E35B22F7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D7F2A4-92A8-91EE-CEBF-581ACE45A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3147BA-CE36-65FF-0F71-92E518AE8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8908D0-6CB8-B226-9846-21667224E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764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668BC0-14E9-235A-EEA7-847788FF83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77E6B7-93A1-ADA9-EE88-3B0591C132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5CBEB1-947F-6F3F-164B-F2A4F354F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AF7A1B-58AC-F524-72F8-6B5153F0B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F9E960-9EA0-804F-2378-AB74B0434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92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F8BA3-0A0C-1E41-C3D8-8D3FCE71E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3B6827-ED33-EBF5-5824-3EDFB7A62E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505C8B-30AA-D21B-951F-07449D0C9F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6F7B12-D687-C534-9CC4-167DCFC37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AF7DE6-CBD6-6526-B3E2-677F97581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052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77AF24-D54B-7FAA-CA54-F367F99CB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629F68-5759-3112-49C4-73516C7832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080514-F19B-3283-5AC9-BF666B7CD7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EA110B-C173-BA1E-D1B8-4EBCF643A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D60987-8D15-F0F8-C488-24284C422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82B333-785B-213B-8CE7-F831F140D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299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C8837-2443-7FBA-C20E-276C2CD95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808763-6F09-9FDE-3151-6D8811123D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02B6E9-CF61-6A42-B711-1D7D7BEDA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71736E-F764-22CE-E91B-6F72BAD6ED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84A322-8D92-04EE-4DAA-9D8A1A5181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3ED5F9-6521-6B63-1048-E31A4D2C1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81C981-CD79-46BB-CB07-75C4AADAB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BA8338-9FA4-2E97-533E-B1045567B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760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92D499-A7A6-8B93-7582-7B29E43EE3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8D04B5-64E6-9ECB-0496-AEB766901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9D578D2-D62F-7495-6B1C-AE49B4F49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D38C9F-90A5-7AAF-706A-C8756DD21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282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224697-2778-9921-F93B-318595D53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C667217-92B1-2B3F-E4CD-BE922BBB2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901829-79EB-87E5-8CEE-D4E0935F1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325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F63E5-AEF0-81BA-284C-2535914949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83FC7E-F104-EFE1-F832-32A4FBE8D3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528976-2522-B21F-55AC-B4A41068F5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AB4558-5F0F-F72E-B4CE-69814C478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644700-3D53-D9FC-2AFA-54B61ADE6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9CB9B2-7708-8BE3-5DD2-BF7DD664C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229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A4834A-29A5-7155-5E6B-21CB59152D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373286-5A31-0BB1-9B08-51ED1EFE0F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60BA23-B1AF-3C36-C600-BA80B3DE4F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E46EA6-AE21-D697-1B3B-0EFB30FBE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ACD81B-0B3C-E293-7AF1-917918C2C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E25CE2-F27D-CDBB-1D56-E98FDDB11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329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20EE56-DD94-58DB-BB08-A68692C50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033696-1C7E-A75E-1114-E46AFE04D8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59E903-B7AC-5D04-D92D-FFF3925FCD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57648B-5E71-E245-B746-5B3D7EC13041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58000F-33C6-9900-F9FD-2938043F46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7ABC9C-FC9F-52AE-73BD-9DA216573F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CBDAFA-7551-324F-838E-5619ABCBD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327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6258C3-111E-5F2D-F97E-351B9E4F7C2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latin typeface="Palatino" pitchFamily="2" charset="77"/>
                <a:ea typeface="Palatino" pitchFamily="2" charset="77"/>
              </a:rPr>
              <a:t>Supplementary material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D8EF71-193C-08CB-6D3F-2F14EFA8E8A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>
                <a:latin typeface="Palatino" pitchFamily="2" charset="77"/>
                <a:ea typeface="Palatino" pitchFamily="2" charset="77"/>
              </a:rPr>
              <a:t>Liliana </a:t>
            </a:r>
            <a:r>
              <a:rPr lang="en-US" dirty="0" err="1">
                <a:latin typeface="Palatino" pitchFamily="2" charset="77"/>
                <a:ea typeface="Palatino" pitchFamily="2" charset="77"/>
              </a:rPr>
              <a:t>Albertazzi</a:t>
            </a:r>
            <a:endParaRPr lang="en-US" dirty="0">
              <a:latin typeface="Palatino" pitchFamily="2" charset="77"/>
              <a:ea typeface="Palatino" pitchFamily="2" charset="77"/>
            </a:endParaRPr>
          </a:p>
        </p:txBody>
      </p:sp>
    </p:spTree>
    <p:extLst>
      <p:ext uri="{BB962C8B-B14F-4D97-AF65-F5344CB8AC3E}">
        <p14:creationId xmlns:p14="http://schemas.microsoft.com/office/powerpoint/2010/main" val="8241448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E7B5DB7-F043-6033-E10C-CBE2712106EF}"/>
              </a:ext>
            </a:extLst>
          </p:cNvPr>
          <p:cNvSpPr txBox="1"/>
          <p:nvPr/>
        </p:nvSpPr>
        <p:spPr>
          <a:xfrm>
            <a:off x="247135" y="4979768"/>
            <a:ext cx="1146707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" pitchFamily="2" charset="77"/>
                <a:ea typeface="Palatino" pitchFamily="2" charset="77"/>
              </a:rPr>
              <a:t>Figure S1. Michotte’s parallelepiped. </a:t>
            </a:r>
            <a:r>
              <a:rPr lang="en-US" dirty="0">
                <a:solidFill>
                  <a:srgbClr val="333333"/>
                </a:solidFill>
                <a:highlight>
                  <a:srgbClr val="FFFFFF"/>
                </a:highlight>
                <a:latin typeface="Palatino" pitchFamily="2" charset="77"/>
                <a:ea typeface="Palatino" pitchFamily="2" charset="77"/>
                <a:cs typeface="Palatino Linotype" panose="02040502050505030304" pitchFamily="18" charset="0"/>
              </a:rPr>
              <a:t>The figure should be observed from point B, with one eye close to to the sheet.</a:t>
            </a:r>
            <a:endParaRPr lang="en-US" dirty="0">
              <a:latin typeface="Palatino" pitchFamily="2" charset="77"/>
              <a:ea typeface="Palatino" pitchFamily="2" charset="77"/>
            </a:endParaRPr>
          </a:p>
          <a:p>
            <a:r>
              <a:rPr lang="en-US" dirty="0">
                <a:latin typeface="Palatino" pitchFamily="2" charset="77"/>
                <a:ea typeface="Palatino" pitchFamily="2" charset="77"/>
              </a:rPr>
              <a:t>From A. </a:t>
            </a:r>
            <a:r>
              <a:rPr lang="en-US" sz="1800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Palatino" pitchFamily="2" charset="77"/>
                <a:ea typeface="Palatino" pitchFamily="2" charset="77"/>
                <a:cs typeface="Palatino Linotype" panose="02040502050505030304" pitchFamily="18" charset="0"/>
              </a:rPr>
              <a:t>Michotte. </a:t>
            </a:r>
            <a:r>
              <a:rPr lang="en-US" sz="1800" i="1" dirty="0">
                <a:solidFill>
                  <a:srgbClr val="333333"/>
                </a:solidFill>
                <a:effectLst/>
                <a:latin typeface="Palatino" pitchFamily="2" charset="77"/>
                <a:ea typeface="Palatino" pitchFamily="2" charset="77"/>
                <a:cs typeface="Palatino Linotype" panose="02040502050505030304" pitchFamily="18" charset="0"/>
              </a:rPr>
              <a:t>Michotte's experimental phenomenology of perception</a:t>
            </a:r>
            <a:r>
              <a:rPr lang="en-US" sz="1800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Palatino" pitchFamily="2" charset="77"/>
                <a:ea typeface="Palatino" pitchFamily="2" charset="77"/>
                <a:cs typeface="Palatino Linotype" panose="02040502050505030304" pitchFamily="18" charset="0"/>
              </a:rPr>
              <a:t>, G. Thinès, A. Costall, G. Butterworth Eds.; Lawrence Erlbaum Associates, Inc., </a:t>
            </a:r>
            <a:r>
              <a:rPr lang="en-US" sz="1800" b="1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Palatino" pitchFamily="2" charset="77"/>
                <a:ea typeface="Palatino" pitchFamily="2" charset="77"/>
                <a:cs typeface="Palatino Linotype" panose="02040502050505030304" pitchFamily="18" charset="0"/>
              </a:rPr>
              <a:t>1991</a:t>
            </a:r>
            <a:r>
              <a:rPr lang="en-US" sz="1800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Palatino" pitchFamily="2" charset="77"/>
                <a:ea typeface="Palatino" pitchFamily="2" charset="77"/>
                <a:cs typeface="Palatino Linotype" panose="02040502050505030304" pitchFamily="18" charset="0"/>
              </a:rPr>
              <a:t>.</a:t>
            </a:r>
          </a:p>
          <a:p>
            <a:endParaRPr lang="en-US" dirty="0"/>
          </a:p>
        </p:txBody>
      </p:sp>
      <p:sp>
        <p:nvSpPr>
          <p:cNvPr id="2" name="Cornice 1">
            <a:extLst>
              <a:ext uri="{FF2B5EF4-FFF2-40B4-BE49-F238E27FC236}">
                <a16:creationId xmlns:a16="http://schemas.microsoft.com/office/drawing/2014/main" id="{D3699728-40C6-3064-64B4-822F39AB6F03}"/>
              </a:ext>
            </a:extLst>
          </p:cNvPr>
          <p:cNvSpPr/>
          <p:nvPr/>
        </p:nvSpPr>
        <p:spPr>
          <a:xfrm>
            <a:off x="3510455" y="1629103"/>
            <a:ext cx="641131" cy="515007"/>
          </a:xfrm>
          <a:prstGeom prst="fram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chemeClr val="tx1"/>
              </a:solidFill>
            </a:endParaRPr>
          </a:p>
        </p:txBody>
      </p:sp>
      <p:grpSp>
        <p:nvGrpSpPr>
          <p:cNvPr id="3" name="Group 48">
            <a:extLst>
              <a:ext uri="{FF2B5EF4-FFF2-40B4-BE49-F238E27FC236}">
                <a16:creationId xmlns:a16="http://schemas.microsoft.com/office/drawing/2014/main" id="{E136B00E-1F87-78CC-5F0C-737D37638929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047543" y="1303287"/>
            <a:ext cx="5080893" cy="3037490"/>
            <a:chOff x="1374" y="10418"/>
            <a:chExt cx="2760" cy="1650"/>
          </a:xfrm>
        </p:grpSpPr>
        <p:sp>
          <p:nvSpPr>
            <p:cNvPr id="6" name="Text Box 19">
              <a:extLst>
                <a:ext uri="{FF2B5EF4-FFF2-40B4-BE49-F238E27FC236}">
                  <a16:creationId xmlns:a16="http://schemas.microsoft.com/office/drawing/2014/main" id="{D08F9E23-38D6-60BB-C007-125BF598D7DB}"/>
                </a:ext>
              </a:extLst>
            </p:cNvPr>
            <p:cNvSpPr txBox="1">
              <a:spLocks noChangeAspect="1" noEditPoints="1" noChangeArrowheads="1" noChangeShapeType="1" noTextEdit="1"/>
            </p:cNvSpPr>
            <p:nvPr/>
          </p:nvSpPr>
          <p:spPr bwMode="auto">
            <a:xfrm>
              <a:off x="3654" y="10418"/>
              <a:ext cx="480" cy="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it-IT" sz="1200" b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</a:t>
              </a:r>
              <a:endParaRPr lang="it-IT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7" name="Group 41">
              <a:extLst>
                <a:ext uri="{FF2B5EF4-FFF2-40B4-BE49-F238E27FC236}">
                  <a16:creationId xmlns:a16="http://schemas.microsoft.com/office/drawing/2014/main" id="{F1D9E3F4-C321-18D8-DF58-5430BFDEF8D3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1374" y="10778"/>
              <a:ext cx="2239" cy="1290"/>
              <a:chOff x="2355" y="7200"/>
              <a:chExt cx="2239" cy="1290"/>
            </a:xfrm>
          </p:grpSpPr>
          <p:cxnSp>
            <p:nvCxnSpPr>
              <p:cNvPr id="8" name="Line 42">
                <a:extLst>
                  <a:ext uri="{FF2B5EF4-FFF2-40B4-BE49-F238E27FC236}">
                    <a16:creationId xmlns:a16="http://schemas.microsoft.com/office/drawing/2014/main" id="{4D2A24DB-1EF8-E382-4F90-39EED458714E}"/>
                  </a:ext>
                </a:extLst>
              </p:cNvPr>
              <p:cNvCxnSpPr>
                <a:cxnSpLocks noChangeAspect="1" noEditPoints="1" noChangeArrowheads="1" noChangeShapeType="1"/>
              </p:cNvCxnSpPr>
              <p:nvPr/>
            </p:nvCxnSpPr>
            <p:spPr bwMode="auto">
              <a:xfrm flipV="1">
                <a:off x="2355" y="7200"/>
                <a:ext cx="1755" cy="81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9" name="Line 43">
                <a:extLst>
                  <a:ext uri="{FF2B5EF4-FFF2-40B4-BE49-F238E27FC236}">
                    <a16:creationId xmlns:a16="http://schemas.microsoft.com/office/drawing/2014/main" id="{4BA762DF-E84A-8403-82C2-2FFED1B95CDB}"/>
                  </a:ext>
                </a:extLst>
              </p:cNvPr>
              <p:cNvCxnSpPr>
                <a:cxnSpLocks noChangeAspect="1" noEditPoints="1" noChangeArrowheads="1" noChangeShapeType="1"/>
              </p:cNvCxnSpPr>
              <p:nvPr/>
            </p:nvCxnSpPr>
            <p:spPr bwMode="auto">
              <a:xfrm flipV="1">
                <a:off x="2831" y="7204"/>
                <a:ext cx="1759" cy="81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0" name="Line 44">
                <a:extLst>
                  <a:ext uri="{FF2B5EF4-FFF2-40B4-BE49-F238E27FC236}">
                    <a16:creationId xmlns:a16="http://schemas.microsoft.com/office/drawing/2014/main" id="{C2A1983B-F403-C254-6A86-BA9D547BF33A}"/>
                  </a:ext>
                </a:extLst>
              </p:cNvPr>
              <p:cNvCxnSpPr>
                <a:cxnSpLocks noChangeAspect="1" noEditPoints="1" noChangeArrowheads="1" noChangeShapeType="1"/>
              </p:cNvCxnSpPr>
              <p:nvPr/>
            </p:nvCxnSpPr>
            <p:spPr bwMode="auto">
              <a:xfrm flipV="1">
                <a:off x="2824" y="7669"/>
                <a:ext cx="1770" cy="82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1" name="Line 45">
                <a:extLst>
                  <a:ext uri="{FF2B5EF4-FFF2-40B4-BE49-F238E27FC236}">
                    <a16:creationId xmlns:a16="http://schemas.microsoft.com/office/drawing/2014/main" id="{0DCC1B8B-59F4-7C0E-3E32-FAA369891BFA}"/>
                  </a:ext>
                </a:extLst>
              </p:cNvPr>
              <p:cNvCxnSpPr>
                <a:cxnSpLocks noChangeAspect="1" noEditPoints="1" noChangeArrowheads="1" noChangeShapeType="1"/>
              </p:cNvCxnSpPr>
              <p:nvPr/>
            </p:nvCxnSpPr>
            <p:spPr bwMode="auto">
              <a:xfrm flipV="1">
                <a:off x="2365" y="7668"/>
                <a:ext cx="1767" cy="81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2" name="Rectangle 46">
                <a:extLst>
                  <a:ext uri="{FF2B5EF4-FFF2-40B4-BE49-F238E27FC236}">
                    <a16:creationId xmlns:a16="http://schemas.microsoft.com/office/drawing/2014/main" id="{4922D2E5-F997-DFA2-49D6-33B1510A773A}"/>
                  </a:ext>
                </a:extLst>
              </p:cNvPr>
              <p:cNvSpPr>
                <a:spLocks noChangeAspect="1" noEditPoints="1" noChangeArrowheads="1" noChangeShapeType="1" noTextEdit="1"/>
              </p:cNvSpPr>
              <p:nvPr/>
            </p:nvSpPr>
            <p:spPr bwMode="auto">
              <a:xfrm>
                <a:off x="4121" y="7200"/>
                <a:ext cx="471" cy="471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it-IT"/>
              </a:p>
            </p:txBody>
          </p:sp>
          <p:sp>
            <p:nvSpPr>
              <p:cNvPr id="13" name="Rectangle 47">
                <a:extLst>
                  <a:ext uri="{FF2B5EF4-FFF2-40B4-BE49-F238E27FC236}">
                    <a16:creationId xmlns:a16="http://schemas.microsoft.com/office/drawing/2014/main" id="{92AC3641-FE88-D8DD-9036-56CEA27AD2C0}"/>
                  </a:ext>
                </a:extLst>
              </p:cNvPr>
              <p:cNvSpPr>
                <a:spLocks noChangeAspect="1" noEditPoints="1" noChangeArrowheads="1" noChangeShapeType="1" noTextEdit="1"/>
              </p:cNvSpPr>
              <p:nvPr/>
            </p:nvSpPr>
            <p:spPr bwMode="auto">
              <a:xfrm>
                <a:off x="2355" y="8018"/>
                <a:ext cx="471" cy="471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it-IT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965463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29A5BEDB-CD5A-FEDD-4BDC-D68BEAB04E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0649" y="1668161"/>
            <a:ext cx="4314482" cy="226746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1">
            <a:extLst>
              <a:ext uri="{FF2B5EF4-FFF2-40B4-BE49-F238E27FC236}">
                <a16:creationId xmlns:a16="http://schemas.microsoft.com/office/drawing/2014/main" id="{BAE3EB50-C230-3695-4512-DEF524F95691}"/>
              </a:ext>
            </a:extLst>
          </p:cNvPr>
          <p:cNvSpPr txBox="1"/>
          <p:nvPr/>
        </p:nvSpPr>
        <p:spPr>
          <a:xfrm>
            <a:off x="284204" y="4547285"/>
            <a:ext cx="11504141" cy="1743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dirty="0">
                <a:latin typeface="Palatino" pitchFamily="2" charset="77"/>
                <a:ea typeface="Palatino" pitchFamily="2" charset="77"/>
              </a:rPr>
              <a:t>Figure S2. Bistable rectangle.</a:t>
            </a:r>
            <a:r>
              <a:rPr lang="en-GB" dirty="0">
                <a:latin typeface="Times New Roman" panose="02020603050405020304" pitchFamily="18" charset="0"/>
                <a:ea typeface="Palatino" pitchFamily="2" charset="77"/>
              </a:rPr>
              <a:t> Seen either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grounded against the black surface;  or behind the black surface (like a “slit</a:t>
            </a:r>
            <a:r>
              <a:rPr lang="en-GB" dirty="0">
                <a:latin typeface="Times New Roman" panose="02020603050405020304" pitchFamily="18" charset="0"/>
                <a:ea typeface="Times New Roman" panose="02020603050405020304" pitchFamily="18" charset="0"/>
              </a:rPr>
              <a:t>”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  </a:t>
            </a:r>
            <a:r>
              <a:rPr lang="en-GB" dirty="0">
                <a:latin typeface="Times New Roman" panose="02020603050405020304" pitchFamily="18" charset="0"/>
                <a:ea typeface="Times New Roman" panose="02020603050405020304" pitchFamily="18" charset="0"/>
              </a:rPr>
              <a:t>If seen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regrounded, the rectangle appears smaller and less clearcut; if seen backgrounded, the rectangle appears larger and more clearcut.  </a:t>
            </a: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rom V. Benussi, </a:t>
            </a:r>
            <a:r>
              <a:rPr lang="it-IT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troduzione alla psicologia sperimentale. Lezioni tenute nell’anno 1922-23</a:t>
            </a:r>
            <a:r>
              <a:rPr lang="it-IT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redatte dal Dott. Musatti, manoscritto.</a:t>
            </a:r>
            <a:r>
              <a:rPr lang="it-IT" dirty="0">
                <a:effectLst/>
              </a:rPr>
              <a:t> 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R="0" lvl="0" algn="just">
              <a:lnSpc>
                <a:spcPct val="95000"/>
              </a:lnSpc>
              <a:spcBef>
                <a:spcPts val="0"/>
              </a:spcBef>
              <a:spcAft>
                <a:spcPts val="0"/>
              </a:spcAft>
            </a:pPr>
            <a:endParaRPr lang="en-US" dirty="0">
              <a:latin typeface="Palatino" pitchFamily="2" charset="77"/>
              <a:ea typeface="Palatino" pitchFamily="2" charset="77"/>
            </a:endParaRPr>
          </a:p>
        </p:txBody>
      </p:sp>
    </p:spTree>
    <p:extLst>
      <p:ext uri="{BB962C8B-B14F-4D97-AF65-F5344CB8AC3E}">
        <p14:creationId xmlns:p14="http://schemas.microsoft.com/office/powerpoint/2010/main" val="11821388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5CB8B8-52B3-9CB6-F786-7FA344FBC165}"/>
              </a:ext>
            </a:extLst>
          </p:cNvPr>
          <p:cNvSpPr txBox="1"/>
          <p:nvPr/>
        </p:nvSpPr>
        <p:spPr>
          <a:xfrm>
            <a:off x="588579" y="5263980"/>
            <a:ext cx="10447283" cy="881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0" lvl="0" algn="just">
              <a:lnSpc>
                <a:spcPct val="9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dirty="0">
                <a:latin typeface="Palatino" pitchFamily="2" charset="77"/>
                <a:ea typeface="Palatino" pitchFamily="2" charset="77"/>
              </a:rPr>
              <a:t>Figure S3. The rotating ellipse. From </a:t>
            </a: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flat rotating ellipse, to elastic ring, to disc. </a:t>
            </a:r>
          </a:p>
          <a:p>
            <a:pPr marR="0" lvl="0" algn="just">
              <a:lnSpc>
                <a:spcPct val="9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From C. Musatti, La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stereocinesi</a:t>
            </a: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 e il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problema</a:t>
            </a: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 della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struttura</a:t>
            </a: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dello</a:t>
            </a: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spazio</a:t>
            </a: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visibile</a:t>
            </a: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Rivista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 di Psicologia</a:t>
            </a: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, 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1995</a:t>
            </a:r>
            <a:r>
              <a:rPr lang="en-US" sz="18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Noto Sans Symbols"/>
              </a:rPr>
              <a:t>, 49, 3-57</a:t>
            </a:r>
            <a:endParaRPr lang="en-US" dirty="0">
              <a:latin typeface="Palatino" pitchFamily="2" charset="77"/>
              <a:ea typeface="Palatino" pitchFamily="2" charset="77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9F4B830F-EC62-AB25-7108-B5B61287D5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735213"/>
            <a:ext cx="7772400" cy="25467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9274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77</Words>
  <Application>Microsoft Office PowerPoint</Application>
  <PresentationFormat>Widescreen</PresentationFormat>
  <Paragraphs>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Palatino</vt:lpstr>
      <vt:lpstr>Aptos</vt:lpstr>
      <vt:lpstr>Aptos Display</vt:lpstr>
      <vt:lpstr>Arial</vt:lpstr>
      <vt:lpstr>Times New Roman</vt:lpstr>
      <vt:lpstr>Office Theme</vt:lpstr>
      <vt:lpstr>Supplementary material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oli, Roberto</dc:creator>
  <cp:lastModifiedBy>MDPI</cp:lastModifiedBy>
  <cp:revision>14</cp:revision>
  <dcterms:created xsi:type="dcterms:W3CDTF">2024-07-10T16:56:41Z</dcterms:created>
  <dcterms:modified xsi:type="dcterms:W3CDTF">2024-07-19T08:23:39Z</dcterms:modified>
</cp:coreProperties>
</file>